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28" autoAdjust="0"/>
    <p:restoredTop sz="94660"/>
  </p:normalViewPr>
  <p:slideViewPr>
    <p:cSldViewPr snapToGrid="0">
      <p:cViewPr>
        <p:scale>
          <a:sx n="150" d="100"/>
          <a:sy n="150" d="100"/>
        </p:scale>
        <p:origin x="2668" y="5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E59B093-EF37-4B5B-9276-F9D5EEBF88E4}" type="datetimeFigureOut">
              <a:rPr lang="en-US" smtClean="0"/>
              <a:pPr>
                <a:defRPr/>
              </a:pPr>
              <a:t>5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5096BC2-F67C-408D-900F-49FED8D00BB2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446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FC67CF0-CFAA-46FF-92D8-9D22E0402532}" type="datetimeFigureOut">
              <a:rPr lang="en-US" smtClean="0"/>
              <a:pPr>
                <a:defRPr/>
              </a:pPr>
              <a:t>5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EE0BDAF-69E9-4372-ACD0-CCA79A3BAA75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740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429F3500-C3F2-4F6A-A0CA-3A9FAB3FF9ED}" type="datetimeFigureOut">
              <a:rPr lang="en-US" smtClean="0"/>
              <a:pPr>
                <a:defRPr/>
              </a:pPr>
              <a:t>5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88F1E034-F9BD-4D62-AF1B-AF76F786315F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2424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08ACFEA-23A1-44D0-AEDF-564EFB981F36}" type="datetimeFigureOut">
              <a:rPr lang="en-US" smtClean="0"/>
              <a:pPr>
                <a:defRPr/>
              </a:pPr>
              <a:t>5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689E694-96CD-4388-9C0B-ADF67F91DFB1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13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9DB8CD5B-4DFE-4CD2-A743-71C487179665}" type="datetimeFigureOut">
              <a:rPr lang="en-US" smtClean="0"/>
              <a:pPr>
                <a:defRPr/>
              </a:pPr>
              <a:t>5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01CE503-3F13-4B97-9AC0-851FED42684F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5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F14B9F0-2B04-4C7D-BE02-5BB94574AD91}" type="datetimeFigureOut">
              <a:rPr lang="en-US" smtClean="0"/>
              <a:pPr>
                <a:defRPr/>
              </a:pPr>
              <a:t>5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1736938-0993-4DD0-8438-5B545B3CD34C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893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98EDCF3-3ABC-4D0E-9C0F-C919484B3BD5}" type="datetimeFigureOut">
              <a:rPr lang="en-US" smtClean="0"/>
              <a:pPr>
                <a:defRPr/>
              </a:pPr>
              <a:t>5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340BAA3-F30E-453F-8DCC-6E850569569A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739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7F1E42ED-E2B9-403C-8ABD-060DB7E2287D}" type="datetimeFigureOut">
              <a:rPr lang="en-US" smtClean="0"/>
              <a:pPr>
                <a:defRPr/>
              </a:pPr>
              <a:t>5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1DE8B77-C841-4FEC-9154-C7C023A46A15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687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BA95EB8-8930-4478-85C9-7CFBA983CF7F}" type="datetimeFigureOut">
              <a:rPr lang="en-US" smtClean="0"/>
              <a:pPr>
                <a:defRPr/>
              </a:pPr>
              <a:t>5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15B156E-09C5-4B9B-A99D-00EFC7DF0286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345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EBA71D9-F53D-478F-9827-604E3D7E1BEB}" type="datetimeFigureOut">
              <a:rPr lang="en-US" smtClean="0"/>
              <a:pPr>
                <a:defRPr/>
              </a:pPr>
              <a:t>5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D9320BD-F3C8-4107-A97D-891225A4C7C8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253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318A7337-653B-4300-893E-AE22E4C6615E}" type="datetimeFigureOut">
              <a:rPr lang="en-US" smtClean="0"/>
              <a:pPr>
                <a:defRPr/>
              </a:pPr>
              <a:t>5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2D4BE89-15EA-4CD1-BD6A-76DA06491B25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254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D8D88B05-C488-4919-B3BA-4D01F5DC070E}" type="datetimeFigureOut">
              <a:rPr lang="en-US" smtClean="0"/>
              <a:pPr>
                <a:defRPr/>
              </a:pPr>
              <a:t>5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7DD1C1C-1C06-485E-943F-D1A0DE97D4E5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902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49996"/>
          <p:cNvSpPr/>
          <p:nvPr/>
        </p:nvSpPr>
        <p:spPr>
          <a:xfrm>
            <a:off x="-1" y="57875"/>
            <a:ext cx="922655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Panatino"/>
              </a:rPr>
              <a:t>Supplemental Figure </a:t>
            </a:r>
            <a:r>
              <a:rPr lang="en-US" sz="1000" b="1" dirty="0" smtClean="0">
                <a:latin typeface="Panatino"/>
              </a:rPr>
              <a:t>S1. </a:t>
            </a:r>
            <a:r>
              <a:rPr lang="en-US" sz="1000" dirty="0" smtClean="0">
                <a:latin typeface="Panatino"/>
              </a:rPr>
              <a:t>Amino acid substitutions of VSBV-1 proteins from different holdings and zoos.</a:t>
            </a:r>
            <a:endParaRPr lang="en-US" sz="1000" dirty="0">
              <a:latin typeface="Panatino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-1" y="1857046"/>
            <a:ext cx="9144000" cy="3202580"/>
            <a:chOff x="1" y="1535314"/>
            <a:chExt cx="9144000" cy="3202580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945" t="12460" r="32389" b="18730"/>
            <a:stretch/>
          </p:blipFill>
          <p:spPr>
            <a:xfrm>
              <a:off x="375920" y="1535314"/>
              <a:ext cx="858520" cy="867525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" y="1535314"/>
              <a:ext cx="9144000" cy="320258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531171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natino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 Cadar</dc:creator>
  <cp:lastModifiedBy>Mordor</cp:lastModifiedBy>
  <cp:revision>81</cp:revision>
  <dcterms:created xsi:type="dcterms:W3CDTF">2019-11-11T06:58:46Z</dcterms:created>
  <dcterms:modified xsi:type="dcterms:W3CDTF">2021-05-10T20:37:03Z</dcterms:modified>
</cp:coreProperties>
</file>